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2537"/>
  </p:normalViewPr>
  <p:slideViewPr>
    <p:cSldViewPr snapToGrid="0">
      <p:cViewPr varScale="1">
        <p:scale>
          <a:sx n="130" d="100"/>
          <a:sy n="130" d="100"/>
        </p:scale>
        <p:origin x="19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227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1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658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554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259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092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145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66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95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26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88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9336E-2D02-488B-A2B1-AF75209874B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A72D2-07F1-448D-BE00-78AD7DD8BD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037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0A91CD6-46B4-4CDD-851A-0415DA0126D8}"/>
              </a:ext>
            </a:extLst>
          </p:cNvPr>
          <p:cNvGrpSpPr/>
          <p:nvPr/>
        </p:nvGrpSpPr>
        <p:grpSpPr>
          <a:xfrm>
            <a:off x="240891" y="636643"/>
            <a:ext cx="8662219" cy="4879254"/>
            <a:chOff x="1280039" y="1864704"/>
            <a:chExt cx="6778047" cy="3383280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09CE0498-E020-4E52-A8E6-C74B4F591A8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280039" y="1864704"/>
              <a:ext cx="3291961" cy="3383280"/>
              <a:chOff x="2981323" y="243336"/>
              <a:chExt cx="3025608" cy="3109539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0142E875-B4A9-4DC2-AA25-0CD836AFD57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64133" y="243915"/>
                <a:ext cx="2842798" cy="3108960"/>
                <a:chOff x="849075" y="714300"/>
                <a:chExt cx="2578575" cy="2820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640E1198-1A13-425C-8204-3E2A301E57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9075" y="7143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02340A1-00D5-4C87-9E2B-0C74A93C10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77650" y="14193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862995D2-6C5E-4D84-8FB9-806EA12A84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77650" y="21243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6A42E53E-52B4-4389-BB83-A4840C8DC8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77650" y="28293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0A84FCF-EA4F-46C5-B211-5BBB51EEABF5}"/>
                  </a:ext>
                </a:extLst>
              </p:cNvPr>
              <p:cNvSpPr txBox="1"/>
              <p:nvPr/>
            </p:nvSpPr>
            <p:spPr>
              <a:xfrm>
                <a:off x="2981323" y="243336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6EF98080-0165-448F-A958-C61F21F950A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36627" y="1864704"/>
              <a:ext cx="3321459" cy="3383280"/>
              <a:chOff x="2985714" y="3504546"/>
              <a:chExt cx="3052720" cy="3109539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2EE28F26-DD6F-4739-82DF-F9577FE90BB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95636" y="3505125"/>
                <a:ext cx="2842798" cy="3108960"/>
                <a:chOff x="4543425" y="714300"/>
                <a:chExt cx="2578575" cy="2820000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E9E1ED0D-8E8B-44EE-8BAD-6FE53A5F4C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72000" y="7143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C6A45531-2005-4A49-B399-CC8C3F6A54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43425" y="14193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70772F79-DD4B-4025-955B-5DD8182866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72000" y="21248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FB5FEC49-35AF-40CD-906D-CA27A13580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72000" y="28293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3F326B9-EDA9-4BAB-96B3-BBD8C9C7A19A}"/>
                  </a:ext>
                </a:extLst>
              </p:cNvPr>
              <p:cNvSpPr txBox="1"/>
              <p:nvPr/>
            </p:nvSpPr>
            <p:spPr>
              <a:xfrm>
                <a:off x="2985714" y="3504546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E7E4E57-A9DD-4FF6-8A1A-214ECEF320D0}"/>
              </a:ext>
            </a:extLst>
          </p:cNvPr>
          <p:cNvSpPr txBox="1"/>
          <p:nvPr/>
        </p:nvSpPr>
        <p:spPr>
          <a:xfrm>
            <a:off x="1417898" y="5831030"/>
            <a:ext cx="706468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0 Fig. PpSP36 nucleotide and amino acid vari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</p:txBody>
      </p:sp>
    </p:spTree>
    <p:extLst>
      <p:ext uri="{BB962C8B-B14F-4D97-AF65-F5344CB8AC3E}">
        <p14:creationId xmlns:p14="http://schemas.microsoft.com/office/powerpoint/2010/main" val="3705108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2</cp:revision>
  <dcterms:created xsi:type="dcterms:W3CDTF">2019-01-18T03:14:49Z</dcterms:created>
  <dcterms:modified xsi:type="dcterms:W3CDTF">2020-06-21T17:50:56Z</dcterms:modified>
</cp:coreProperties>
</file>